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5" r:id="rId2"/>
    <p:sldId id="276" r:id="rId3"/>
    <p:sldId id="26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893"/>
    <p:restoredTop sz="80885" autoAdjust="0"/>
  </p:normalViewPr>
  <p:slideViewPr>
    <p:cSldViewPr>
      <p:cViewPr varScale="1">
        <p:scale>
          <a:sx n="92" d="100"/>
          <a:sy n="92" d="100"/>
        </p:scale>
        <p:origin x="18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E235AE-0360-7446-9F3B-F72530413E34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312BC7-9F1F-8041-A3DA-E58296FA6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2212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l Table 1: Dose Levels for Phase 1 Study of Trametinib and Pembrolizumab in Advanced NSCLC Patients</a:t>
            </a:r>
          </a:p>
        </p:txBody>
      </p:sp>
    </p:spTree>
    <p:extLst>
      <p:ext uri="{BB962C8B-B14F-4D97-AF65-F5344CB8AC3E}">
        <p14:creationId xmlns:p14="http://schemas.microsoft.com/office/powerpoint/2010/main" val="323824710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5312BC7-9F1F-8041-A3DA-E58296FA6B73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13458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12BFB4-3115-4A4E-A9F9-DFBCBD72815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275A72-51F6-47C1-9B63-B781CD8AAB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2C5E6F-3C50-42D0-8254-36924D6F4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6E4733-AD71-4C7D-AA28-C135AA7C2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48C547-FDC1-4F7F-BED7-9EB4FE8BCE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827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085112-DC3A-4E2E-9F73-81AA857E72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FB8C462-098C-4FCA-960B-56FDABC002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9CA3B2-4B74-44B6-8026-15AA771480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191BB7-1A8F-424F-AE49-65F55A6C1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323CA5-F9CB-4095-B554-801B088652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47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3944CEA-E4BC-4B44-B51C-080605CCA55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D685E0-C1B8-43DB-87E9-4BA943FA14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79574B-7762-494B-8B35-5320F7B8EF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B40320-C6D1-4B8A-8113-D65A2ACC9E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A34D73-981D-4546-94F5-6ED153BF47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35579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Defau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381247361"/>
      </p:ext>
    </p:extLst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5A5DD3-87CE-4AB1-A24E-01E3F61101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D092FD-C7E1-4F75-9B26-9E2D7E1406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344E88-3943-45DE-BB71-EBD2F6315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A73781-FE4A-4B74-81A9-070D0984D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200359-8BA5-4A4F-8FDE-FD60115A0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713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D54FA0-F99B-4093-9102-5D366B16DC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A251FC-75F1-4C5A-A38D-B836966721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B0AB8A-4EB6-451F-AAFF-CE27880F0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0668F5-62AD-44F8-83C3-E7B1223C82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5AE9BA-BAAE-4229-B1E9-0ECF9C840F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667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9FBB58-DFD1-40E6-A001-1ABFE03E28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F821E89-B224-409C-8821-9FA89C217FB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DCCADE-67A9-4D76-9AB6-860C0768E7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5155B5-F6AC-4282-8577-9520D110E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132988-3E96-496F-8AF4-36A1A8B06E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3ED497-2E0C-4AC0-A4FB-87F5B7A3B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1596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1AEA26-B824-4516-9467-AD2D25869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F0FBB6-EC21-45DD-A381-D09520EAD3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1CCC5C0-E1BF-444A-B697-3AF18C0F85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D1B7B5-CB25-4103-ACC8-B5378181E6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DE9F8D6-6458-41FD-A21D-06883114B58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B799EB-CB45-4919-AB13-AC218EC943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BA2DF48-90B3-4C65-ADAA-BF4A22C07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5E809E7-D934-4D47-93B3-5A531C7AB9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453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331D9E-7110-40A3-A6D4-2ABC3E0A60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95A4927-4993-4995-BD0A-FCE69278E4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174A53-C3CE-4F5D-8E16-3D580B2C62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704BCC7-6760-4138-9D9B-226A7A3C3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26885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3B33131-279D-468A-AEFA-52C14C71C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73D4970-19D2-42B6-8D69-E8BF518402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F0E822-0D54-46AD-8469-D44CD0937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8692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E226A2-1552-4557-8E7D-2B02988B18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15FFDE-1BC9-4D50-A961-5740D66EC0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B011B8-2AD1-4ADB-9875-148010F48B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F3CB4C-7482-471A-9C6A-805B3C4CD1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39FB3F-DC93-4E44-9095-575AF5954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6F70C5-A666-4D44-BF95-F7B1686724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477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BA6813-83DC-4346-A203-70A33B2CD2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8D3A5F3-BF21-4FDA-8264-04CE098558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27CF1C-BD1F-4891-A3B1-A5FB24E864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096AE48-AF24-4D72-93D6-A6EFEE2D4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D198E0-47C7-4C55-ACDC-1931AE9CE4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0F5E27-4E21-45DE-B1D6-66B9580FA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985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909D09F-5094-4A20-A585-D61C636EB9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FA5C09-F82B-439F-9368-5031B628AF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0E83C8-54E4-4C51-BDF0-6C544F317D0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673836-00BE-426F-9BD4-2315C03629E2}" type="datetimeFigureOut">
              <a:rPr lang="en-US" smtClean="0"/>
              <a:t>10/21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C827A8-B50C-4DA2-80D6-8C13B42D47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6D75D3-0963-44B2-840C-76879367AE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F3C66D-FBD3-4CFF-B434-35B85DDBDA5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05025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5901E836-3BA3-CA4E-87AA-B5F3BF1ED1F3}"/>
              </a:ext>
            </a:extLst>
          </p:cNvPr>
          <p:cNvSpPr>
            <a:spLocks noGrp="1"/>
          </p:cNvSpPr>
          <p:nvPr/>
        </p:nvSpPr>
        <p:spPr>
          <a:xfrm>
            <a:off x="609600" y="1363668"/>
            <a:ext cx="10972800" cy="6034619"/>
          </a:xfrm>
          <a:prstGeom prst="rect">
            <a:avLst/>
          </a:prstGeom>
        </p:spPr>
        <p:txBody>
          <a:bodyPr vert="horz" lIns="121920" tIns="60960" rIns="121920" bIns="6096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4C7A47BA-4876-EB4D-80EF-DB53140E2D34}"/>
              </a:ext>
            </a:extLst>
          </p:cNvPr>
          <p:cNvGraphicFramePr>
            <a:graphicFrameLocks noGrp="1"/>
          </p:cNvGraphicFramePr>
          <p:nvPr/>
        </p:nvGraphicFramePr>
        <p:xfrm>
          <a:off x="1110613" y="1363669"/>
          <a:ext cx="9670147" cy="200744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1380897">
                  <a:extLst>
                    <a:ext uri="{9D8B030D-6E8A-4147-A177-3AD203B41FA5}">
                      <a16:colId xmlns:a16="http://schemas.microsoft.com/office/drawing/2014/main" val="2274726714"/>
                    </a:ext>
                  </a:extLst>
                </a:gridCol>
                <a:gridCol w="3490923">
                  <a:extLst>
                    <a:ext uri="{9D8B030D-6E8A-4147-A177-3AD203B41FA5}">
                      <a16:colId xmlns:a16="http://schemas.microsoft.com/office/drawing/2014/main" val="2677998391"/>
                    </a:ext>
                  </a:extLst>
                </a:gridCol>
                <a:gridCol w="4798327">
                  <a:extLst>
                    <a:ext uri="{9D8B030D-6E8A-4147-A177-3AD203B41FA5}">
                      <a16:colId xmlns:a16="http://schemas.microsoft.com/office/drawing/2014/main" val="2933727947"/>
                    </a:ext>
                  </a:extLst>
                </a:gridCol>
              </a:tblGrid>
              <a:tr h="59182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dirty="0">
                          <a:effectLst/>
                        </a:rPr>
                        <a:t>Dose Level</a:t>
                      </a:r>
                      <a:endParaRPr lang="en-US" sz="1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it-IT" sz="1600" dirty="0" err="1">
                          <a:effectLst/>
                        </a:rPr>
                        <a:t>Trametinib</a:t>
                      </a:r>
                      <a:r>
                        <a:rPr lang="it-IT" sz="1600" dirty="0">
                          <a:effectLst/>
                        </a:rPr>
                        <a:t> dose </a:t>
                      </a:r>
                      <a:br>
                        <a:rPr lang="it-IT" sz="1600" dirty="0">
                          <a:effectLst/>
                        </a:rPr>
                      </a:br>
                      <a:r>
                        <a:rPr lang="it-IT" sz="1600" dirty="0">
                          <a:effectLst/>
                        </a:rPr>
                        <a:t>(PO </a:t>
                      </a:r>
                      <a:r>
                        <a:rPr lang="it-IT" sz="1600" dirty="0" err="1">
                          <a:effectLst/>
                        </a:rPr>
                        <a:t>Daily</a:t>
                      </a:r>
                      <a:r>
                        <a:rPr lang="it-IT" sz="1600" dirty="0">
                          <a:effectLst/>
                        </a:rPr>
                        <a:t>) Q3W</a:t>
                      </a:r>
                      <a:endParaRPr lang="en-US" sz="16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>
                          <a:effectLst/>
                        </a:rPr>
                        <a:t>Pembrolizumab (MK-3475) dose IV Q3W</a:t>
                      </a:r>
                      <a:endParaRPr lang="en-US" sz="1600" b="1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extLst>
                  <a:ext uri="{0D108BD9-81ED-4DB2-BD59-A6C34878D82A}">
                    <a16:rowId xmlns:a16="http://schemas.microsoft.com/office/drawing/2014/main" val="4032697255"/>
                  </a:ext>
                </a:extLst>
              </a:tr>
              <a:tr h="2929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>
                          <a:effectLst/>
                        </a:rPr>
                        <a:t>-1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 dirty="0">
                          <a:effectLst/>
                        </a:rPr>
                        <a:t>1.5 mg (D1-D7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 dirty="0">
                          <a:effectLst/>
                        </a:rPr>
                        <a:t>200 mg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extLst>
                  <a:ext uri="{0D108BD9-81ED-4DB2-BD59-A6C34878D82A}">
                    <a16:rowId xmlns:a16="http://schemas.microsoft.com/office/drawing/2014/main" val="953565528"/>
                  </a:ext>
                </a:extLst>
              </a:tr>
              <a:tr h="2929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>
                          <a:effectLst/>
                        </a:rPr>
                        <a:t>*1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 dirty="0">
                          <a:effectLst/>
                        </a:rPr>
                        <a:t>1.5 mg (D1-D10)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 dirty="0">
                          <a:effectLst/>
                        </a:rPr>
                        <a:t>200 mg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extLst>
                  <a:ext uri="{0D108BD9-81ED-4DB2-BD59-A6C34878D82A}">
                    <a16:rowId xmlns:a16="http://schemas.microsoft.com/office/drawing/2014/main" val="332638234"/>
                  </a:ext>
                </a:extLst>
              </a:tr>
              <a:tr h="29294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>
                          <a:effectLst/>
                        </a:rPr>
                        <a:t>2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>
                          <a:effectLst/>
                        </a:rPr>
                        <a:t>2.0 mg (D1-D10)</a:t>
                      </a:r>
                      <a:endParaRPr lang="en-US" sz="16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300"/>
                        </a:spcAft>
                      </a:pPr>
                      <a:r>
                        <a:rPr lang="en-US" sz="1600" dirty="0">
                          <a:effectLst/>
                        </a:rPr>
                        <a:t>200 mg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extLst>
                  <a:ext uri="{0D108BD9-81ED-4DB2-BD59-A6C34878D82A}">
                    <a16:rowId xmlns:a16="http://schemas.microsoft.com/office/drawing/2014/main" val="1578101747"/>
                  </a:ext>
                </a:extLst>
              </a:tr>
              <a:tr h="536787">
                <a:tc gridSpan="3">
                  <a:txBody>
                    <a:bodyPr/>
                    <a:lstStyle/>
                    <a:p>
                      <a:pPr marL="104140" marR="0" indent="-124460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104140" algn="l"/>
                        </a:tabLst>
                      </a:pPr>
                      <a:r>
                        <a:rPr lang="en-GB" sz="1600" dirty="0">
                          <a:effectLst/>
                        </a:rPr>
                        <a:t>*	Dose level 1 is the starting dose. For each cohort, trametinib dose will be the same for lead in and for concurrent trametinib + pembrolizumab administration.</a:t>
                      </a:r>
                      <a:endParaRPr lang="en-US" sz="16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</a:endParaRPr>
                    </a:p>
                  </a:txBody>
                  <a:tcPr marL="97367" marR="97367" marT="24553" marB="24553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9952041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33527E10-25AE-5551-3A5E-A7A1A92C0064}"/>
              </a:ext>
            </a:extLst>
          </p:cNvPr>
          <p:cNvSpPr txBox="1"/>
          <p:nvPr/>
        </p:nvSpPr>
        <p:spPr>
          <a:xfrm>
            <a:off x="685800" y="228600"/>
            <a:ext cx="111208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1: Dose Levels for Phase 1 Study of Trametinib and Pembrolizumab in Advanced NSCLC Patients</a:t>
            </a:r>
          </a:p>
        </p:txBody>
      </p:sp>
    </p:spTree>
    <p:extLst>
      <p:ext uri="{BB962C8B-B14F-4D97-AF65-F5344CB8AC3E}">
        <p14:creationId xmlns:p14="http://schemas.microsoft.com/office/powerpoint/2010/main" val="1885400326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C62B6A2-AA10-53CD-FE11-55AC199828C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6528862"/>
              </p:ext>
            </p:extLst>
          </p:nvPr>
        </p:nvGraphicFramePr>
        <p:xfrm>
          <a:off x="1447800" y="504799"/>
          <a:ext cx="9500667" cy="6325492"/>
        </p:xfrm>
        <a:graphic>
          <a:graphicData uri="http://schemas.openxmlformats.org/drawingml/2006/table">
            <a:tbl>
              <a:tblPr>
                <a:tableStyleId>{8799B23B-EC83-4686-B30A-512413B5E67A}</a:tableStyleId>
              </a:tblPr>
              <a:tblGrid>
                <a:gridCol w="2145596">
                  <a:extLst>
                    <a:ext uri="{9D8B030D-6E8A-4147-A177-3AD203B41FA5}">
                      <a16:colId xmlns:a16="http://schemas.microsoft.com/office/drawing/2014/main" val="1615564510"/>
                    </a:ext>
                  </a:extLst>
                </a:gridCol>
                <a:gridCol w="1245305">
                  <a:extLst>
                    <a:ext uri="{9D8B030D-6E8A-4147-A177-3AD203B41FA5}">
                      <a16:colId xmlns:a16="http://schemas.microsoft.com/office/drawing/2014/main" val="4072076399"/>
                    </a:ext>
                  </a:extLst>
                </a:gridCol>
                <a:gridCol w="1622449">
                  <a:extLst>
                    <a:ext uri="{9D8B030D-6E8A-4147-A177-3AD203B41FA5}">
                      <a16:colId xmlns:a16="http://schemas.microsoft.com/office/drawing/2014/main" val="2374865400"/>
                    </a:ext>
                  </a:extLst>
                </a:gridCol>
                <a:gridCol w="2530586">
                  <a:extLst>
                    <a:ext uri="{9D8B030D-6E8A-4147-A177-3AD203B41FA5}">
                      <a16:colId xmlns:a16="http://schemas.microsoft.com/office/drawing/2014/main" val="2594231658"/>
                    </a:ext>
                  </a:extLst>
                </a:gridCol>
                <a:gridCol w="1956731">
                  <a:extLst>
                    <a:ext uri="{9D8B030D-6E8A-4147-A177-3AD203B41FA5}">
                      <a16:colId xmlns:a16="http://schemas.microsoft.com/office/drawing/2014/main" val="1096800616"/>
                    </a:ext>
                  </a:extLst>
                </a:gridCol>
              </a:tblGrid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>
                          <a:solidFill>
                            <a:srgbClr val="000000"/>
                          </a:solidFill>
                          <a:effectLst/>
                        </a:rPr>
                        <a:t>Panel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>
                          <a:solidFill>
                            <a:srgbClr val="000000"/>
                          </a:solidFill>
                          <a:effectLst/>
                        </a:rPr>
                        <a:t>Traget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>
                          <a:solidFill>
                            <a:srgbClr val="000000"/>
                          </a:solidFill>
                          <a:effectLst/>
                        </a:rPr>
                        <a:t>Fluorophore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>
                          <a:solidFill>
                            <a:srgbClr val="000000"/>
                          </a:solidFill>
                          <a:effectLst/>
                        </a:rPr>
                        <a:t>Company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1" u="none" strike="noStrike">
                          <a:solidFill>
                            <a:srgbClr val="000000"/>
                          </a:solidFill>
                          <a:effectLst/>
                        </a:rPr>
                        <a:t>Reference</a:t>
                      </a:r>
                      <a:endParaRPr lang="en-US" sz="1050" b="1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33474153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Live dea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qu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hermoFisher Sc.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L231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961663110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B5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51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813353043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uV39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410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72784024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uV73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4629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585862783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197/CCR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lexa64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081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176970089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45R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ECy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121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175059258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HLADR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ECF59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233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934070326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19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V78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332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382290603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5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V71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74078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360158761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 Subset/B/N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1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lexa7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579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263539791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Live dea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qu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hermoFisher Sc.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L231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718709769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B5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51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543110604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uV39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BD</a:t>
                      </a:r>
                      <a:r>
                        <a:rPr lang="en-US" sz="105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 Bioscienc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410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757386396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uV73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4629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000956730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2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lexa7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139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4171150543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FoxP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B7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652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07392678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D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ECF59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502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439236809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Ki6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V60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 dirty="0" err="1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35052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506968861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iCOS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lexa64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283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922256091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reg/Tac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223/Lag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V78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74472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959614867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Live dea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qu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ThermoFisher Sc.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L2310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037848143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V71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ioLegen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31732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112881073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5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V71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303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616196247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19 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V71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74078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3514618068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1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ECy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5540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485808404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3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B5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458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103839467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HLADR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ECF59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233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432234116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11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ECy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652358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41178475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1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uV73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444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4098892459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66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uV39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740314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1518424560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CD274/PDL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56831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2434838192"/>
                  </a:ext>
                </a:extLst>
              </a:tr>
              <a:tr h="191655"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MDSC/APC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CD273/PDL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PerCPCy5.5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>
                          <a:solidFill>
                            <a:srgbClr val="000000"/>
                          </a:solidFill>
                          <a:effectLst/>
                        </a:rPr>
                        <a:t>BD Biosci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50" b="0" u="none" strike="noStrike" dirty="0">
                          <a:solidFill>
                            <a:srgbClr val="000000"/>
                          </a:solidFill>
                          <a:effectLst/>
                        </a:rPr>
                        <a:t>56425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4292" marR="4292" marT="4292" marB="20600" anchor="b"/>
                </a:tc>
                <a:extLst>
                  <a:ext uri="{0D108BD9-81ED-4DB2-BD59-A6C34878D82A}">
                    <a16:rowId xmlns:a16="http://schemas.microsoft.com/office/drawing/2014/main" val="8597737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4A407D1C-831A-957C-BF1C-2D6D8F4F6FDF}"/>
              </a:ext>
            </a:extLst>
          </p:cNvPr>
          <p:cNvSpPr txBox="1"/>
          <p:nvPr/>
        </p:nvSpPr>
        <p:spPr>
          <a:xfrm>
            <a:off x="2819400" y="41564"/>
            <a:ext cx="6248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Table 2: Antibody Cocktails </a:t>
            </a:r>
          </a:p>
        </p:txBody>
      </p:sp>
    </p:spTree>
    <p:extLst>
      <p:ext uri="{BB962C8B-B14F-4D97-AF65-F5344CB8AC3E}">
        <p14:creationId xmlns:p14="http://schemas.microsoft.com/office/powerpoint/2010/main" val="4078394858"/>
      </p:ext>
    </p:extLst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3C35A5FC-4993-E142-B31B-F1298E2175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3383119"/>
              </p:ext>
            </p:extLst>
          </p:nvPr>
        </p:nvGraphicFramePr>
        <p:xfrm>
          <a:off x="152400" y="762000"/>
          <a:ext cx="11689080" cy="4078605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990600">
                  <a:extLst>
                    <a:ext uri="{9D8B030D-6E8A-4147-A177-3AD203B41FA5}">
                      <a16:colId xmlns:a16="http://schemas.microsoft.com/office/drawing/2014/main" val="354790086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483401301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339709452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1620383788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893685284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1812441802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405182578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1071643453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537954344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2086635314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4009463539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582710513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1934964229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2779461836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522592864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92436578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3079923528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1298833363"/>
                    </a:ext>
                  </a:extLst>
                </a:gridCol>
                <a:gridCol w="594360">
                  <a:extLst>
                    <a:ext uri="{9D8B030D-6E8A-4147-A177-3AD203B41FA5}">
                      <a16:colId xmlns:a16="http://schemas.microsoft.com/office/drawing/2014/main" val="4193306001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arameter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D8 Stroma</a:t>
                      </a:r>
                    </a:p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(me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D8 Tumor</a:t>
                      </a:r>
                    </a:p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(me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CD8 (mean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D4 Stroma (me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D4 Tumor</a:t>
                      </a:r>
                    </a:p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(me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4 Total (mean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D20 Stroma</a:t>
                      </a:r>
                    </a:p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(me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CD20 Tumor</a:t>
                      </a:r>
                    </a:p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(me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p valu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 CD20 (mean)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 value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9888015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Age, y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924077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&lt;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5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36.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981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287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631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758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85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15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912829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&gt;65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6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4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4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2883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3131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360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651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430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497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3</a:t>
                      </a:r>
                    </a:p>
                  </a:txBody>
                  <a:tcPr marL="9525" marR="9525" marT="9525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0928167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ex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7760504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5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91.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83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229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931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128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892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68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14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835723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Femal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6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5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286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340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108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923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063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524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5445971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u="none" strike="noStrike" dirty="0">
                          <a:effectLst/>
                        </a:rPr>
                        <a:t>Smoke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552031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N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3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1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8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8917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010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062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927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54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80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1462388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6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43.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</a:rPr>
                        <a:t>0.0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10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939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318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7045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031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198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545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46063953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ior Treatment</a:t>
                      </a:r>
                    </a:p>
                  </a:txBody>
                  <a:tcPr marL="9525" marR="9525" marT="9525" marB="0" anchor="ctr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9596804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Immunotherapy naiv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1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37.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750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873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167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49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553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19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9682646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munotherapy treated</a:t>
                      </a:r>
                    </a:p>
                  </a:txBody>
                  <a:tcPr marL="9525" marR="9525" marT="9525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5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1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78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25118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5232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5500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468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1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76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93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855025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A4DEC047-99BD-B292-2555-7CE50D9C484C}"/>
              </a:ext>
            </a:extLst>
          </p:cNvPr>
          <p:cNvSpPr txBox="1"/>
          <p:nvPr/>
        </p:nvSpPr>
        <p:spPr>
          <a:xfrm>
            <a:off x="685800" y="228600"/>
            <a:ext cx="72408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Table 3: Immune Profile According to Patient Demographics</a:t>
            </a:r>
          </a:p>
        </p:txBody>
      </p:sp>
    </p:spTree>
    <p:extLst>
      <p:ext uri="{BB962C8B-B14F-4D97-AF65-F5344CB8AC3E}">
        <p14:creationId xmlns:p14="http://schemas.microsoft.com/office/powerpoint/2010/main" val="38900061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56</TotalTime>
  <Words>621</Words>
  <Application>Microsoft Macintosh PowerPoint</Application>
  <PresentationFormat>Widescreen</PresentationFormat>
  <Paragraphs>327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 Narrow</vt:lpstr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pez de Rodas Gregorio, Miguel</dc:creator>
  <cp:lastModifiedBy>Matthew Lara</cp:lastModifiedBy>
  <cp:revision>79</cp:revision>
  <dcterms:created xsi:type="dcterms:W3CDTF">2021-01-09T21:35:16Z</dcterms:created>
  <dcterms:modified xsi:type="dcterms:W3CDTF">2024-10-22T03:17:09Z</dcterms:modified>
</cp:coreProperties>
</file>